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378" r:id="rId2"/>
    <p:sldId id="257" r:id="rId3"/>
    <p:sldId id="367" r:id="rId4"/>
    <p:sldId id="270" r:id="rId5"/>
    <p:sldId id="376" r:id="rId6"/>
    <p:sldId id="370" r:id="rId7"/>
    <p:sldId id="373" r:id="rId8"/>
    <p:sldId id="369" r:id="rId9"/>
    <p:sldId id="377" r:id="rId10"/>
    <p:sldId id="365" r:id="rId11"/>
    <p:sldId id="379" r:id="rId12"/>
    <p:sldId id="374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812" autoAdjust="0"/>
    <p:restoredTop sz="87126" autoAdjust="0"/>
  </p:normalViewPr>
  <p:slideViewPr>
    <p:cSldViewPr snapToGrid="0">
      <p:cViewPr varScale="1">
        <p:scale>
          <a:sx n="76" d="100"/>
          <a:sy n="76" d="100"/>
        </p:scale>
        <p:origin x="60" y="3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77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522BDC-13FD-409D-ACBB-8D77FB6977F8}" type="datetimeFigureOut">
              <a:rPr lang="en-US" smtClean="0"/>
              <a:t>1/15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D3F473-2C48-4302-B61C-188FCE81D0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51465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35762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7264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45152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tabLst/>
              <a:defRPr/>
            </a:pPr>
            <a:endParaRPr lang="en-US" b="0" i="0" dirty="0">
              <a:solidFill>
                <a:srgbClr val="1D1C1D"/>
              </a:solidFill>
              <a:effectLst/>
              <a:latin typeface="Slack-Lato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51577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64522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525F84F-4724-9FA9-017F-C8654E84609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CFD4228F-AD5C-370D-954E-744E649C4D5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BBC85FD4-387B-CC94-B4EA-AE32F60B061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60D1A1C-549C-CA18-0557-8B4CED29EF9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78941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70466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>
              <a:spcAft>
                <a:spcPts val="300"/>
              </a:spcAft>
              <a:buNone/>
            </a:pPr>
            <a:endParaRPr lang="en-US" b="0" i="0" dirty="0">
              <a:solidFill>
                <a:srgbClr val="1D1C1D"/>
              </a:solidFill>
              <a:effectLst/>
              <a:latin typeface="Slack-Lato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51577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935069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3F473-2C48-4302-B61C-188FCE81D00F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2927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F947F1-7A15-CFA5-830F-775A9E8FE9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462A4E-4655-F7CC-4AE2-D6ED78046B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A3D53B-D6ED-4538-CF14-42F38859C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1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209BD7-5185-4C51-7CF5-AE9791C313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812FEC-86F5-73A1-5716-099CD069A9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484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446E35-BA2A-38A6-A1D1-B38B49EE98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896422-46B2-4EFA-5E75-E9463D62B4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868E47-9DF5-B4FD-C6C9-93D883394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1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9082F2-6401-E855-AA86-F7B5DA9A6D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46818A-5AA1-394A-D10E-30978B6C2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462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FE1BFEE-D31E-0CB0-5730-F5D045E7A4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B851D5-9CCF-24A8-8136-F4C1697B83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73D1F9-6BAE-72E1-9136-EF1E2DF86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1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7E7F51-14B3-E015-775B-4260F36EF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8DEF0E-060F-A859-5C4C-704405E6A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637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D92F31-1C4A-4115-64BF-DEC90E2EAC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73BECF-9C8C-1239-0C9D-FB20F7C501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CD7CA9-3B63-8371-66EC-D7103843A0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1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543D88-8008-E295-0024-E25E89D0CF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664637-E784-1733-DE88-BAD2C41A1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400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5896DC-94DF-9639-97B4-DD8A59F248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5D1DFF-F6FC-8B15-2E8B-329B61E191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3498C2-ACB4-4A3E-9105-48195345F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1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2AE333-2A2F-B1B7-727D-FDAF35121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74D114-4582-5886-0735-5762B53E1E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75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97AA70-6932-3AF2-3E49-3B7C4EF659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04EE5C-5712-D337-9644-FE37406E4B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CFAA91-E37E-5369-4CE7-B20E879E32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71CABA-04E4-7ABE-A2B4-D79A95DED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1/1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7979C0-8E0F-89D2-AD5C-32F968C55F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45A808-812E-720B-1C93-B798FFA33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628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BB2C60-151F-56BF-1B31-D51A99B572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A44A19-6268-71C2-74FE-E394F186E0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23CB93-547D-8362-C72B-E4EBCF3CFD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46FA15A-5217-32A4-F897-59E9141FD1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2CE1848-A188-699D-135E-5B4BC43867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90008AF-1941-A5E5-6C4F-A23F470132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1/15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830F59-425B-13A4-59DD-B704BF2FD5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EF89BE-F65A-E682-FD2B-596457AEB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823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D52668-7E9B-97C2-5A90-401E763304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EEC0EF4-DBBA-D0C7-FBB7-32182C4A88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1/15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2992DD-2A1D-425F-0CBA-0E8D236D4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5964E8C-A62D-F16C-73F0-11384B76B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997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71AFE2-0F80-4666-9301-CC4DF4902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1/15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75D861-5234-6EF5-7866-B8350389C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85DE15A-53B1-B930-59D8-E4901F5CA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6546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7F5E9E-358C-3360-7EDC-459A0A1606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56CCF5-37C4-2A89-0BF4-6CB0CA224E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54C73B-B790-B081-0E99-621C597F77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696EBE-1D69-7407-8345-9198369DE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1/1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DE8256-BDA6-48DB-AA5F-A37C9354DE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E13F31-5068-8B42-7028-E119E236D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333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B3F5AB-FB4E-D929-734E-4C75361D72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050160-6A0A-6D14-37FB-EDA1B9B006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FE0095-563D-BFEF-65DC-A19387E028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84CB39-1793-D3C9-2673-999E52B709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72464F-9E18-445E-9763-89F477CAB759}" type="datetimeFigureOut">
              <a:rPr lang="en-US" smtClean="0"/>
              <a:t>1/1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2E89DC-E306-4D93-F33A-505318296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970381-A956-DC62-8A78-2553C506E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974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C822E59-5F8F-7998-9A23-0A54BA905C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E1F488-B4FE-9BDE-18FD-3C0350E539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53392B-12B8-930A-4F62-595C730CCB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772464F-9E18-445E-9763-89F477CAB759}" type="datetimeFigureOut">
              <a:rPr lang="en-US" smtClean="0"/>
              <a:t>1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E41C10-E1F0-E16A-6B44-D3DA61F902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9C4725-648F-5AA6-5B02-B301576B0E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F1D1D70-3F7E-4C83-86AB-4E2AF1E969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903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4.emf"/><Relationship Id="rId4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11" Type="http://schemas.openxmlformats.org/officeDocument/2006/relationships/image" Target="../media/image5.png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7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88A4E9-B302-871C-0A64-3DD6EECF39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84935" y="113016"/>
            <a:ext cx="11148316" cy="6667928"/>
          </a:xfrm>
        </p:spPr>
        <p:txBody>
          <a:bodyPr>
            <a:noAutofit/>
          </a:bodyPr>
          <a:lstStyle/>
          <a:p>
            <a:pPr marL="0" indent="0">
              <a:buNone/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Information 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. RNA-Seq raw reads with Q20/Q30 scores, insert sizes and alignment rates. PCA plots indicate replicate variability. Red outline indicates BF samples, black outline shows RVFV samples, and green outline highlights SF samples.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2. RNA-Seq DESeq2 analysis for all samples and timepoints. 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3. Normalized Enrichment Score Table for RVFV v BF time course using custom annotation.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4. CUT&amp;RUN-Seq raw reads with Q20/Q30 scores, insert sizes and alignment rates. PCA plots indicate replicate variability. Red outline indicates BF samples, black outline shows RVFV samples, and green outline highlights SF samples.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5. H3K27ac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DiffBin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output for genes within 2kB of TSS.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6. H3K9me3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DiffBin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output for genes within 2kB of TSS.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7. RVFV v BF DEGs with proximal histone peak changes.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S8. Ci/GLI promoter regions identified using HOMER.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Supplementary Table S9. RT-qPCR primers.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. S1. MA plots of RNA-Seq differential expression data.  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. S2. GO-GSEA of RVFV v BF RNA-Seq differential expression data.  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. S3. Over-representation analysis of all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Ae. aegypti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enes with Ci/Gli motif.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. S4. GO-GSEA of BF vs SF RNA-Seq transcript differential expression data.  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. S5. H3K27ac and H3K9me3 peak profiles. Top row: H3K27ac Input-subtracted peak heatmaps of aligned reads at 1, 3 and 7 days post-treatment show global trends within 2 kB of TSS (x axis). Y-axis indicates RPGC (reads per genome coverage) of input-subtracted read alignments. Notice the different Y-axis scales. Bottom row: H3K9me3 Input-subtracted peak heatmaps.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. S6. RVFV vs BF datasets: GSEA of GOIs proximal to H3K27Ac and H3K9me3 marks. 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. S7. GO categories for genes proximal to H3K27ac marks change over time. A. GO terms for genes within 2kB of TSS (MACS2 peak calls) displayed using over-representation analysis. X axis shows collection day (d1, d3, or d7), BF,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bloodfe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, SF, sugar-fed. Number in parentheses below the sample name indicates the number of macs2 peaks considered in the analysis. This is a qualitative analysis and does not indicate statistically significant differences between groups. B. Transition of GO terms over time in BF midguts. GO terms for genes within 2kB of TSS (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DiffBin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peak calls) displayed using over-representation analysis.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. S8.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BFvSF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1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dpf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: Relationship of H3K27ac peaks and DEGs. Coordinates for DEG start sites (DEG Log2FC, right y-axis) were plotted alongside H3K27ac peak coordinates and fold-change values (Peak FC, left y-axis).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. S9. H3K9me3 RVFV vs BF vs SF peak heatmaps. Input-subtracted H3K9me3 peak heatmaps of aligned reads at 1, 3 and 7 days post-treatment show global trends within 2 kB of TSS (x axis). Y-axis indicates RPGC (reads per genome coverage) of input-subtracted read alignments. 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. S10. Over representation analysis of gene functional groups proximal to depleted H3K9me3 peaks in RVFV v BF samples at 3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dpe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marL="0" indent="0">
              <a:buNone/>
            </a:pP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upplementary Fig. S11. Enhancers. A. GSEA functional groups of genes at the BF v SF 1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dpf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timepoint that showed predicted H3K27ac peaks. B. Proportion of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DiffBin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peaks within 2 kB of TSS (FDR &lt;= 0.10) for H3K27ac, (red = enriched, blue = depleted) and H3K9me3 (orange = enriched, maroon = depleted). Total numbers of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DiffBin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peaks within 2 kB of TSS listed to the right of the bars. </a:t>
            </a:r>
          </a:p>
          <a:p>
            <a:pPr marL="0" indent="0">
              <a:buNone/>
            </a:pP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251022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blue and white vertical lines&#10;&#10;AI-generated content may be incorrect.">
            <a:extLst>
              <a:ext uri="{FF2B5EF4-FFF2-40B4-BE49-F238E27FC236}">
                <a16:creationId xmlns:a16="http://schemas.microsoft.com/office/drawing/2014/main" id="{3B352A32-0D92-BF13-2966-1541527C894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4653" y="1339358"/>
            <a:ext cx="2390968" cy="5102352"/>
          </a:xfrm>
          <a:prstGeom prst="rect">
            <a:avLst/>
          </a:prstGeom>
        </p:spPr>
      </p:pic>
      <p:pic>
        <p:nvPicPr>
          <p:cNvPr id="15" name="Picture 14" descr="A screenshot of a graph&#10;&#10;AI-generated content may be incorrect.">
            <a:extLst>
              <a:ext uri="{FF2B5EF4-FFF2-40B4-BE49-F238E27FC236}">
                <a16:creationId xmlns:a16="http://schemas.microsoft.com/office/drawing/2014/main" id="{78FA07C1-4B83-DB4E-431C-5DF040BCFE1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2639" y="1339358"/>
            <a:ext cx="2390968" cy="5102352"/>
          </a:xfrm>
          <a:prstGeom prst="rect">
            <a:avLst/>
          </a:prstGeom>
        </p:spPr>
      </p:pic>
      <p:pic>
        <p:nvPicPr>
          <p:cNvPr id="17" name="Picture 16" descr="A screenshot of a graph&#10;&#10;AI-generated content may be incorrect.">
            <a:extLst>
              <a:ext uri="{FF2B5EF4-FFF2-40B4-BE49-F238E27FC236}">
                <a16:creationId xmlns:a16="http://schemas.microsoft.com/office/drawing/2014/main" id="{7FFB93AD-AAB1-BFC5-4896-864EC02E7A9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0074" y="1339358"/>
            <a:ext cx="2390968" cy="510235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6CDCAD6-84C7-FDB5-8DBB-8A093CDD9DA7}"/>
              </a:ext>
            </a:extLst>
          </p:cNvPr>
          <p:cNvSpPr txBox="1"/>
          <p:nvPr/>
        </p:nvSpPr>
        <p:spPr>
          <a:xfrm>
            <a:off x="3323238" y="734780"/>
            <a:ext cx="4572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800" b="1" dirty="0"/>
              <a:t>H3K9me3 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492FCCB-A1E5-C900-C338-044BC28740DC}"/>
              </a:ext>
            </a:extLst>
          </p:cNvPr>
          <p:cNvSpPr/>
          <p:nvPr/>
        </p:nvSpPr>
        <p:spPr>
          <a:xfrm>
            <a:off x="2695336" y="1425281"/>
            <a:ext cx="5836851" cy="2700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itle 1">
            <a:extLst>
              <a:ext uri="{FF2B5EF4-FFF2-40B4-BE49-F238E27FC236}">
                <a16:creationId xmlns:a16="http://schemas.microsoft.com/office/drawing/2014/main" id="{1C15A198-0096-53F8-8E89-F0A0F4BC4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61682" y="884974"/>
            <a:ext cx="6190844" cy="1194594"/>
          </a:xfrm>
          <a:solidFill>
            <a:schemeClr val="bg1"/>
          </a:solidFill>
        </p:spPr>
        <p:txBody>
          <a:bodyPr>
            <a:norm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1                      d3                      d7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A3E0DDE-8D4D-40E8-F2A6-0AF42C706F91}"/>
              </a:ext>
            </a:extLst>
          </p:cNvPr>
          <p:cNvSpPr txBox="1"/>
          <p:nvPr/>
        </p:nvSpPr>
        <p:spPr>
          <a:xfrm>
            <a:off x="2825589" y="1588966"/>
            <a:ext cx="6993518" cy="46166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F  BF RVFV   SF   BF RVFV   SF   BF RVFV    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DECE994-D0C8-DF8D-4821-F17641483A65}"/>
              </a:ext>
            </a:extLst>
          </p:cNvPr>
          <p:cNvSpPr txBox="1"/>
          <p:nvPr/>
        </p:nvSpPr>
        <p:spPr>
          <a:xfrm>
            <a:off x="2695336" y="6154137"/>
            <a:ext cx="6691255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TSS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   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 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       </a:t>
            </a:r>
            <a:r>
              <a:rPr lang="en-US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S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9B197CE2-C420-A9FE-0B10-485E3DD08418}"/>
              </a:ext>
            </a:extLst>
          </p:cNvPr>
          <p:cNvSpPr/>
          <p:nvPr/>
        </p:nvSpPr>
        <p:spPr>
          <a:xfrm>
            <a:off x="4676340" y="1988226"/>
            <a:ext cx="213918" cy="41976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4D4C5C0-055A-DF95-F050-D9CB35C5568C}"/>
              </a:ext>
            </a:extLst>
          </p:cNvPr>
          <p:cNvSpPr/>
          <p:nvPr/>
        </p:nvSpPr>
        <p:spPr>
          <a:xfrm>
            <a:off x="6905442" y="2047313"/>
            <a:ext cx="278547" cy="41385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E552856-A71B-7CD4-D151-0C296DF23A86}"/>
              </a:ext>
            </a:extLst>
          </p:cNvPr>
          <p:cNvSpPr txBox="1"/>
          <p:nvPr/>
        </p:nvSpPr>
        <p:spPr>
          <a:xfrm>
            <a:off x="9250868" y="1991058"/>
            <a:ext cx="404278" cy="45320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900" dirty="0"/>
              <a:t>- 60</a:t>
            </a:r>
          </a:p>
          <a:p>
            <a:endParaRPr lang="en-US" sz="900" dirty="0"/>
          </a:p>
          <a:p>
            <a:endParaRPr lang="en-US" sz="2000" dirty="0"/>
          </a:p>
          <a:p>
            <a:r>
              <a:rPr lang="en-US" sz="900" dirty="0"/>
              <a:t>- 50</a:t>
            </a:r>
          </a:p>
          <a:p>
            <a:endParaRPr lang="en-US" sz="2000" dirty="0"/>
          </a:p>
          <a:p>
            <a:endParaRPr lang="en-US" sz="1050" dirty="0"/>
          </a:p>
          <a:p>
            <a:r>
              <a:rPr lang="en-US" sz="900" dirty="0"/>
              <a:t>- 40</a:t>
            </a:r>
          </a:p>
          <a:p>
            <a:endParaRPr lang="en-US" sz="900" dirty="0"/>
          </a:p>
          <a:p>
            <a:endParaRPr lang="en-US" sz="2000" dirty="0"/>
          </a:p>
          <a:p>
            <a:r>
              <a:rPr lang="en-US" sz="900" dirty="0"/>
              <a:t>- 30</a:t>
            </a:r>
          </a:p>
          <a:p>
            <a:endParaRPr lang="en-US" sz="2000" dirty="0"/>
          </a:p>
          <a:p>
            <a:endParaRPr lang="en-US" sz="900" dirty="0"/>
          </a:p>
          <a:p>
            <a:r>
              <a:rPr lang="en-US" sz="900" dirty="0"/>
              <a:t>- 20</a:t>
            </a:r>
          </a:p>
          <a:p>
            <a:pPr marL="171450" indent="-171450">
              <a:buFontTx/>
              <a:buChar char="-"/>
            </a:pPr>
            <a:endParaRPr lang="en-US" sz="2000" dirty="0"/>
          </a:p>
          <a:p>
            <a:endParaRPr lang="en-US" sz="900" dirty="0"/>
          </a:p>
          <a:p>
            <a:r>
              <a:rPr lang="en-US" sz="900" dirty="0"/>
              <a:t>- 10</a:t>
            </a:r>
          </a:p>
          <a:p>
            <a:endParaRPr lang="en-US" sz="1200" dirty="0"/>
          </a:p>
          <a:p>
            <a:endParaRPr lang="en-US" sz="2000" dirty="0"/>
          </a:p>
          <a:p>
            <a:r>
              <a:rPr lang="en-US" sz="900" dirty="0"/>
              <a:t>- 0.0</a:t>
            </a:r>
          </a:p>
          <a:p>
            <a:endParaRPr lang="en-US" sz="2000" dirty="0"/>
          </a:p>
          <a:p>
            <a:endParaRPr lang="en-US" sz="900" dirty="0"/>
          </a:p>
          <a:p>
            <a:r>
              <a:rPr lang="en-US" sz="900" dirty="0"/>
              <a:t>-</a:t>
            </a:r>
            <a:r>
              <a:rPr lang="en-US" sz="900" baseline="30000" dirty="0"/>
              <a:t>-</a:t>
            </a:r>
            <a:r>
              <a:rPr lang="en-US" sz="900" dirty="0"/>
              <a:t>10</a:t>
            </a:r>
          </a:p>
          <a:p>
            <a:endParaRPr lang="en-US" sz="9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272C564-8B34-ABDA-2B30-CF7526C7AB2D}"/>
              </a:ext>
            </a:extLst>
          </p:cNvPr>
          <p:cNvSpPr txBox="1"/>
          <p:nvPr/>
        </p:nvSpPr>
        <p:spPr>
          <a:xfrm>
            <a:off x="3762123" y="645476"/>
            <a:ext cx="4572000" cy="46166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H3K9me3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973CD5F-8A20-8CCF-1086-5ADF8DF33A7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384" y="55272"/>
            <a:ext cx="17443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9</a:t>
            </a:r>
          </a:p>
        </p:txBody>
      </p:sp>
    </p:spTree>
    <p:extLst>
      <p:ext uri="{BB962C8B-B14F-4D97-AF65-F5344CB8AC3E}">
        <p14:creationId xmlns:p14="http://schemas.microsoft.com/office/powerpoint/2010/main" val="230154343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graph with red and blue dots&#10;&#10;AI-generated content may be incorrect.">
            <a:extLst>
              <a:ext uri="{FF2B5EF4-FFF2-40B4-BE49-F238E27FC236}">
                <a16:creationId xmlns:a16="http://schemas.microsoft.com/office/drawing/2014/main" id="{6BCAD9D8-B8DD-F55E-FCFF-1ED54FB0A30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9095" y="632178"/>
            <a:ext cx="5995029" cy="5330296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C4634D3-1302-8C79-C21C-C0A4CCB3B4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384" y="55272"/>
            <a:ext cx="182934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10</a:t>
            </a:r>
          </a:p>
        </p:txBody>
      </p:sp>
    </p:spTree>
    <p:extLst>
      <p:ext uri="{BB962C8B-B14F-4D97-AF65-F5344CB8AC3E}">
        <p14:creationId xmlns:p14="http://schemas.microsoft.com/office/powerpoint/2010/main" val="170473526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 descr="A graph with red and blue dots&#10;&#10;AI-generated content may be incorrect.">
            <a:extLst>
              <a:ext uri="{FF2B5EF4-FFF2-40B4-BE49-F238E27FC236}">
                <a16:creationId xmlns:a16="http://schemas.microsoft.com/office/drawing/2014/main" id="{C139A957-6C2E-AD52-0DD0-107ECA6A4AD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163" y="382831"/>
            <a:ext cx="4862977" cy="609233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771E480-FC52-AA59-1389-2EDA07E18F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525" y="302268"/>
            <a:ext cx="407484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1">
            <a:extLst>
              <a:ext uri="{FF2B5EF4-FFF2-40B4-BE49-F238E27FC236}">
                <a16:creationId xmlns:a16="http://schemas.microsoft.com/office/drawing/2014/main" id="{578A30D0-AB9D-63C2-E47C-00E0098A88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05630" y="382831"/>
            <a:ext cx="330097" cy="4669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C3CA9744-32B6-4B73-4685-D9EFCDAEA2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68921"/>
              </p:ext>
            </p:extLst>
          </p:nvPr>
        </p:nvGraphicFramePr>
        <p:xfrm>
          <a:off x="5083141" y="1493229"/>
          <a:ext cx="7271748" cy="3653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6711129" imgH="3372482" progId="Prism10.Document">
                  <p:embed/>
                </p:oleObj>
              </mc:Choice>
              <mc:Fallback>
                <p:oleObj name="Prism 10" r:id="rId4" imgW="6711129" imgH="337248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083141" y="1493229"/>
                        <a:ext cx="7271748" cy="3653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EE7234C-B57B-4454-42DE-1137D541C1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384" y="55272"/>
            <a:ext cx="182088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11</a:t>
            </a:r>
          </a:p>
        </p:txBody>
      </p:sp>
    </p:spTree>
    <p:extLst>
      <p:ext uri="{BB962C8B-B14F-4D97-AF65-F5344CB8AC3E}">
        <p14:creationId xmlns:p14="http://schemas.microsoft.com/office/powerpoint/2010/main" val="10545524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939D32FD-02E5-CD7C-F6F1-9EF84358D7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7650858"/>
              </p:ext>
            </p:extLst>
          </p:nvPr>
        </p:nvGraphicFramePr>
        <p:xfrm>
          <a:off x="375202" y="4118558"/>
          <a:ext cx="3482848" cy="23616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Acrobat Document" r:id="rId3" imgW="6124332" imgH="4152877" progId="Acrobat.Document.DC">
                  <p:embed/>
                </p:oleObj>
              </mc:Choice>
              <mc:Fallback>
                <p:oleObj name="Acrobat Document" r:id="rId3" imgW="6124332" imgH="4152877" progId="Acrobat.Document.DC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939D32FD-02E5-CD7C-F6F1-9EF84358D7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5202" y="4118558"/>
                        <a:ext cx="3482848" cy="23616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4A9A7021-753E-7EF8-DC2C-5187167043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5271283"/>
              </p:ext>
            </p:extLst>
          </p:nvPr>
        </p:nvGraphicFramePr>
        <p:xfrm>
          <a:off x="4689438" y="4118558"/>
          <a:ext cx="2816205" cy="23616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Acrobat Document" r:id="rId5" imgW="4838649" imgH="4057377" progId="Acrobat.Document.DC">
                  <p:embed/>
                </p:oleObj>
              </mc:Choice>
              <mc:Fallback>
                <p:oleObj name="Acrobat Document" r:id="rId5" imgW="4838649" imgH="4057377" progId="Acrobat.Document.DC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4A9A7021-753E-7EF8-DC2C-51871670438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89438" y="4118558"/>
                        <a:ext cx="2816205" cy="23616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02C10A81-D988-B816-D7DA-5E7161AB90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366023"/>
              </p:ext>
            </p:extLst>
          </p:nvPr>
        </p:nvGraphicFramePr>
        <p:xfrm>
          <a:off x="8306462" y="4118558"/>
          <a:ext cx="3482848" cy="23616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Acrobat Document" r:id="rId7" imgW="6124332" imgH="4152877" progId="Acrobat.Document.DC">
                  <p:embed/>
                </p:oleObj>
              </mc:Choice>
              <mc:Fallback>
                <p:oleObj name="Acrobat Document" r:id="rId7" imgW="6124332" imgH="4152877" progId="Acrobat.Document.DC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02C10A81-D988-B816-D7DA-5E7161AB90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306462" y="4118558"/>
                        <a:ext cx="3482848" cy="23616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9815E076-A23D-6FB6-0D3C-559A39871C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210156"/>
              </p:ext>
            </p:extLst>
          </p:nvPr>
        </p:nvGraphicFramePr>
        <p:xfrm>
          <a:off x="8664088" y="917246"/>
          <a:ext cx="2922984" cy="24511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Acrobat Document" r:id="rId9" imgW="4838649" imgH="4057377" progId="Acrobat.Document.DC">
                  <p:embed/>
                </p:oleObj>
              </mc:Choice>
              <mc:Fallback>
                <p:oleObj name="Acrobat Document" r:id="rId9" imgW="4838649" imgH="4057377" progId="Acrobat.Document.DC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9815E076-A23D-6FB6-0D3C-559A39871C1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664088" y="917246"/>
                        <a:ext cx="2922984" cy="24511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" name="Picture 7" descr="A graph with dots on it&#10;&#10;AI-generated content may be incorrect.">
            <a:extLst>
              <a:ext uri="{FF2B5EF4-FFF2-40B4-BE49-F238E27FC236}">
                <a16:creationId xmlns:a16="http://schemas.microsoft.com/office/drawing/2014/main" id="{D64CC165-2844-EBF4-18E0-B5F6A8FBABE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51" t="28497" r="1419" b="-1390"/>
          <a:stretch/>
        </p:blipFill>
        <p:spPr>
          <a:xfrm>
            <a:off x="1112928" y="1032714"/>
            <a:ext cx="2053605" cy="2220229"/>
          </a:xfrm>
          <a:prstGeom prst="rect">
            <a:avLst/>
          </a:prstGeom>
        </p:spPr>
      </p:pic>
      <p:pic>
        <p:nvPicPr>
          <p:cNvPr id="14" name="Picture 13" descr="A graph of blue and grey dots&#10;&#10;AI-generated content may be incorrect.">
            <a:extLst>
              <a:ext uri="{FF2B5EF4-FFF2-40B4-BE49-F238E27FC236}">
                <a16:creationId xmlns:a16="http://schemas.microsoft.com/office/drawing/2014/main" id="{0DF000E0-CDA9-54D2-CC83-1B74EB5B0D3F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1114" y="856656"/>
            <a:ext cx="2310697" cy="257234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2EC561E-3C52-98BA-B263-24C123D4E011}"/>
              </a:ext>
            </a:extLst>
          </p:cNvPr>
          <p:cNvSpPr txBox="1"/>
          <p:nvPr/>
        </p:nvSpPr>
        <p:spPr>
          <a:xfrm>
            <a:off x="1009740" y="624661"/>
            <a:ext cx="13694070" cy="37856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RVFVvBF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d1                          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RVFVvBF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d3                         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RVFVvBF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d7                                        </a:t>
            </a: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BFvSF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day 1                           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BFvSF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day 3	                    </a:t>
            </a:r>
            <a:r>
              <a:rPr lang="en-US" sz="2400" b="1" dirty="0" err="1">
                <a:latin typeface="Arial" panose="020B0604020202020204" pitchFamily="34" charset="0"/>
                <a:cs typeface="Arial" panose="020B0604020202020204" pitchFamily="34" charset="0"/>
              </a:rPr>
              <a:t>BFvSF</a:t>
            </a:r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day 7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B052FF9-EF66-3F6B-EDD2-06D71CC902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384" y="55272"/>
            <a:ext cx="17443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1</a:t>
            </a:r>
          </a:p>
        </p:txBody>
      </p:sp>
    </p:spTree>
    <p:extLst>
      <p:ext uri="{BB962C8B-B14F-4D97-AF65-F5344CB8AC3E}">
        <p14:creationId xmlns:p14="http://schemas.microsoft.com/office/powerpoint/2010/main" val="18523213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BF0E8C04-6E38-22D4-9F66-6FC51B8BF7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5413" y="1534540"/>
            <a:ext cx="10017408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ay        1                                              3                                          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E6E3C4E-8309-C1DF-C6C3-3DBFDC88B4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23100" y="839528"/>
            <a:ext cx="1921552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RVFV v BF  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3B260A18-B022-0B9C-DBDD-1825FEECC02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308" y="2001234"/>
            <a:ext cx="4413733" cy="3250496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DE6B96FB-9EF5-2EEF-EDDA-E137656CC90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28157" y="2001234"/>
            <a:ext cx="4420564" cy="3255526"/>
          </a:xfrm>
          <a:prstGeom prst="rect">
            <a:avLst/>
          </a:prstGeom>
        </p:spPr>
      </p:pic>
      <p:pic>
        <p:nvPicPr>
          <p:cNvPr id="18" name="Picture 17" descr="A graph with red and blue dots&#10;&#10;AI-generated content may be incorrect.">
            <a:extLst>
              <a:ext uri="{FF2B5EF4-FFF2-40B4-BE49-F238E27FC236}">
                <a16:creationId xmlns:a16="http://schemas.microsoft.com/office/drawing/2014/main" id="{0C86A95E-08DF-430D-05B7-452CE4779DC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48721" y="2001234"/>
            <a:ext cx="3546971" cy="333069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16125FD-1095-BFA1-6377-1D0CFF985D3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384" y="55272"/>
            <a:ext cx="17443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2</a:t>
            </a:r>
          </a:p>
        </p:txBody>
      </p:sp>
    </p:spTree>
    <p:extLst>
      <p:ext uri="{BB962C8B-B14F-4D97-AF65-F5344CB8AC3E}">
        <p14:creationId xmlns:p14="http://schemas.microsoft.com/office/powerpoint/2010/main" val="1046231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DBFA153-E99A-AAD8-6DAA-3D72DF463DA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A2AF4D5-30D4-1B39-F5FE-DCBAAD4A7B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84996" y="587195"/>
            <a:ext cx="9163904" cy="627080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06798EF-F3C6-35F5-10B6-E5657FDC61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21915" y="242062"/>
            <a:ext cx="5341527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Genes with Ci/Gli Motif in Promoter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01A896A-F113-EE9A-A45B-01F6E43960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384" y="55272"/>
            <a:ext cx="17443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3</a:t>
            </a:r>
          </a:p>
        </p:txBody>
      </p:sp>
    </p:spTree>
    <p:extLst>
      <p:ext uri="{BB962C8B-B14F-4D97-AF65-F5344CB8AC3E}">
        <p14:creationId xmlns:p14="http://schemas.microsoft.com/office/powerpoint/2010/main" val="2227171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B971961-E871-708F-7E4A-F21BC7ABC2A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8A6C3A33-DFC5-4E15-503C-C4CC4DED88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3874" y="1563178"/>
            <a:ext cx="10017408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ay        1                                              3                                             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AC850A9-D14E-0B0B-AE30-0201FBA7B4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88915" y="814611"/>
            <a:ext cx="141417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F v SF </a:t>
            </a:r>
          </a:p>
        </p:txBody>
      </p:sp>
      <p:pic>
        <p:nvPicPr>
          <p:cNvPr id="2" name="Picture 1" descr="A graph with red and blue dots&#10;&#10;AI-generated content may be incorrect.">
            <a:extLst>
              <a:ext uri="{FF2B5EF4-FFF2-40B4-BE49-F238E27FC236}">
                <a16:creationId xmlns:a16="http://schemas.microsoft.com/office/drawing/2014/main" id="{96C48D2E-7C2D-1549-99CC-91DEC53575F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51069"/>
            <a:ext cx="4119589" cy="3289027"/>
          </a:xfrm>
          <a:prstGeom prst="rect">
            <a:avLst/>
          </a:prstGeom>
        </p:spPr>
      </p:pic>
      <p:pic>
        <p:nvPicPr>
          <p:cNvPr id="3" name="Picture 2" descr="A graph with numbers and text&#10;&#10;AI-generated content may be incorrect.">
            <a:extLst>
              <a:ext uri="{FF2B5EF4-FFF2-40B4-BE49-F238E27FC236}">
                <a16:creationId xmlns:a16="http://schemas.microsoft.com/office/drawing/2014/main" id="{A1849C89-C6C8-5E1E-8F9B-325EADA2485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9589" y="2051068"/>
            <a:ext cx="4119589" cy="3289027"/>
          </a:xfrm>
          <a:prstGeom prst="rect">
            <a:avLst/>
          </a:prstGeom>
        </p:spPr>
      </p:pic>
      <p:pic>
        <p:nvPicPr>
          <p:cNvPr id="4" name="Picture 3" descr="A graph with red and blue dots&#10;&#10;AI-generated content may be incorrect.">
            <a:extLst>
              <a:ext uri="{FF2B5EF4-FFF2-40B4-BE49-F238E27FC236}">
                <a16:creationId xmlns:a16="http://schemas.microsoft.com/office/drawing/2014/main" id="{692546F1-A5EE-2ED5-0D33-8BF309890CE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8817" y="1996204"/>
            <a:ext cx="3920254" cy="328902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5C43E57-BCAA-88D3-C2C7-5320B5D944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384" y="55272"/>
            <a:ext cx="17443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4</a:t>
            </a:r>
          </a:p>
        </p:txBody>
      </p:sp>
    </p:spTree>
    <p:extLst>
      <p:ext uri="{BB962C8B-B14F-4D97-AF65-F5344CB8AC3E}">
        <p14:creationId xmlns:p14="http://schemas.microsoft.com/office/powerpoint/2010/main" val="8662191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 descr="A graph of a number of people&#10;&#10;AI-generated content may be incorrect.">
            <a:extLst>
              <a:ext uri="{FF2B5EF4-FFF2-40B4-BE49-F238E27FC236}">
                <a16:creationId xmlns:a16="http://schemas.microsoft.com/office/drawing/2014/main" id="{86BDEE11-4536-8B45-4B61-F91D08FFDBF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7976" y="250710"/>
            <a:ext cx="4024024" cy="2560320"/>
          </a:xfrm>
          <a:prstGeom prst="rect">
            <a:avLst/>
          </a:prstGeom>
        </p:spPr>
      </p:pic>
      <p:pic>
        <p:nvPicPr>
          <p:cNvPr id="26" name="Picture 25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72F056C8-07A9-3879-0C7F-75D44FD2FA5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4024" y="4046970"/>
            <a:ext cx="4024024" cy="2560320"/>
          </a:xfrm>
          <a:prstGeom prst="rect">
            <a:avLst/>
          </a:prstGeom>
        </p:spPr>
      </p:pic>
      <p:pic>
        <p:nvPicPr>
          <p:cNvPr id="28" name="Picture 27" descr="A graph of a number of people&#10;&#10;AI-generated content may be incorrect.">
            <a:extLst>
              <a:ext uri="{FF2B5EF4-FFF2-40B4-BE49-F238E27FC236}">
                <a16:creationId xmlns:a16="http://schemas.microsoft.com/office/drawing/2014/main" id="{A4E458F9-B8B4-D52F-62AD-1D42E32B09A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4024" y="250710"/>
            <a:ext cx="4024024" cy="2560320"/>
          </a:xfrm>
          <a:prstGeom prst="rect">
            <a:avLst/>
          </a:prstGeom>
        </p:spPr>
      </p:pic>
      <p:pic>
        <p:nvPicPr>
          <p:cNvPr id="30" name="Picture 29" descr="A graph of a number of blue and orange lines&#10;&#10;AI-generated content may be incorrect.">
            <a:extLst>
              <a:ext uri="{FF2B5EF4-FFF2-40B4-BE49-F238E27FC236}">
                <a16:creationId xmlns:a16="http://schemas.microsoft.com/office/drawing/2014/main" id="{39F4FA37-B3D1-79F6-7A1D-70770F330BF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046970"/>
            <a:ext cx="4024024" cy="2560320"/>
          </a:xfrm>
          <a:prstGeom prst="rect">
            <a:avLst/>
          </a:prstGeom>
        </p:spPr>
      </p:pic>
      <p:pic>
        <p:nvPicPr>
          <p:cNvPr id="32" name="Picture 31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9087DE72-54A3-436E-F522-91D44E68132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50710"/>
            <a:ext cx="4024024" cy="2560320"/>
          </a:xfrm>
          <a:prstGeom prst="rect">
            <a:avLst/>
          </a:prstGeom>
        </p:spPr>
      </p:pic>
      <p:pic>
        <p:nvPicPr>
          <p:cNvPr id="34" name="Picture 33" descr="A graph of blue and orange lines&#10;&#10;AI-generated content may be incorrect.">
            <a:extLst>
              <a:ext uri="{FF2B5EF4-FFF2-40B4-BE49-F238E27FC236}">
                <a16:creationId xmlns:a16="http://schemas.microsoft.com/office/drawing/2014/main" id="{6D59F488-DF90-696C-7E7F-19F5D73E570E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7976" y="4046970"/>
            <a:ext cx="4024024" cy="256032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7A8E115-857E-58DF-B207-F34E5C0277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384" y="55272"/>
            <a:ext cx="17443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5</a:t>
            </a:r>
          </a:p>
        </p:txBody>
      </p:sp>
    </p:spTree>
    <p:extLst>
      <p:ext uri="{BB962C8B-B14F-4D97-AF65-F5344CB8AC3E}">
        <p14:creationId xmlns:p14="http://schemas.microsoft.com/office/powerpoint/2010/main" val="39623594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7E6E3C4E-8309-C1DF-C6C3-3DBFDC88B4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103401" y="1507324"/>
            <a:ext cx="1979571" cy="37856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 H3K27ac                                         </a:t>
            </a: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      H3K9me3</a:t>
            </a:r>
          </a:p>
        </p:txBody>
      </p:sp>
      <p:pic>
        <p:nvPicPr>
          <p:cNvPr id="7" name="Picture 6" descr="A graph of a number of cells&#10;&#10;AI-generated content may be incorrect.">
            <a:extLst>
              <a:ext uri="{FF2B5EF4-FFF2-40B4-BE49-F238E27FC236}">
                <a16:creationId xmlns:a16="http://schemas.microsoft.com/office/drawing/2014/main" id="{5C6A0A72-FC9E-E909-BDCB-AA3A78B8BA0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5649" y="232991"/>
            <a:ext cx="3058814" cy="3227832"/>
          </a:xfrm>
          <a:prstGeom prst="rect">
            <a:avLst/>
          </a:prstGeom>
        </p:spPr>
      </p:pic>
      <p:pic>
        <p:nvPicPr>
          <p:cNvPr id="9" name="Picture 8" descr="A graph with blue dots&#10;&#10;AI-generated content may be incorrect.">
            <a:extLst>
              <a:ext uri="{FF2B5EF4-FFF2-40B4-BE49-F238E27FC236}">
                <a16:creationId xmlns:a16="http://schemas.microsoft.com/office/drawing/2014/main" id="{F2C3AD9D-9E62-E18D-1EC2-27AADA32BB3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6170" y="3370940"/>
            <a:ext cx="3255778" cy="3435681"/>
          </a:xfrm>
          <a:prstGeom prst="rect">
            <a:avLst/>
          </a:prstGeom>
        </p:spPr>
      </p:pic>
      <p:pic>
        <p:nvPicPr>
          <p:cNvPr id="13" name="Picture 12" descr="A graph with numbers and dots&#10;&#10;AI-generated content may be incorrect.">
            <a:extLst>
              <a:ext uri="{FF2B5EF4-FFF2-40B4-BE49-F238E27FC236}">
                <a16:creationId xmlns:a16="http://schemas.microsoft.com/office/drawing/2014/main" id="{5BB4FB13-184A-6CF4-6BCE-A4E93CCFB12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7141" y="3581388"/>
            <a:ext cx="3056351" cy="3225233"/>
          </a:xfrm>
          <a:prstGeom prst="rect">
            <a:avLst/>
          </a:prstGeom>
        </p:spPr>
      </p:pic>
      <p:pic>
        <p:nvPicPr>
          <p:cNvPr id="3" name="Picture 2" descr="A graph of a number of dots&#10;&#10;AI-generated content may be incorrect.">
            <a:extLst>
              <a:ext uri="{FF2B5EF4-FFF2-40B4-BE49-F238E27FC236}">
                <a16:creationId xmlns:a16="http://schemas.microsoft.com/office/drawing/2014/main" id="{53F01894-5FD3-E029-FE0D-8B30A53C64D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4652" y="283606"/>
            <a:ext cx="3058814" cy="3227832"/>
          </a:xfrm>
          <a:prstGeom prst="rect">
            <a:avLst/>
          </a:prstGeom>
        </p:spPr>
      </p:pic>
      <p:pic>
        <p:nvPicPr>
          <p:cNvPr id="15" name="Picture 14" descr="A screen shot of a graph&#10;&#10;AI-generated content may be incorrect.">
            <a:extLst>
              <a:ext uri="{FF2B5EF4-FFF2-40B4-BE49-F238E27FC236}">
                <a16:creationId xmlns:a16="http://schemas.microsoft.com/office/drawing/2014/main" id="{E28986F2-4C29-4124-800C-19AA8FE1474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5649" y="3581387"/>
            <a:ext cx="3056351" cy="3225234"/>
          </a:xfrm>
          <a:prstGeom prst="rect">
            <a:avLst/>
          </a:prstGeom>
        </p:spPr>
      </p:pic>
      <p:pic>
        <p:nvPicPr>
          <p:cNvPr id="17" name="Picture 16" descr="A chart with yellow dots&#10;&#10;AI-generated content may be incorrect.">
            <a:extLst>
              <a:ext uri="{FF2B5EF4-FFF2-40B4-BE49-F238E27FC236}">
                <a16:creationId xmlns:a16="http://schemas.microsoft.com/office/drawing/2014/main" id="{32E8E0A7-4B2D-B1A1-C7A6-F0BD4F4B358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07714" y="283606"/>
            <a:ext cx="3255778" cy="322783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F0E8C04-6E38-22D4-9F66-6FC51B8BF7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36889" y="-32817"/>
            <a:ext cx="979685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ay         1                                        3                                           7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33F48AB-8D50-7246-842C-7943A04BA2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384" y="55272"/>
            <a:ext cx="17443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6</a:t>
            </a:r>
          </a:p>
        </p:txBody>
      </p:sp>
    </p:spTree>
    <p:extLst>
      <p:ext uri="{BB962C8B-B14F-4D97-AF65-F5344CB8AC3E}">
        <p14:creationId xmlns:p14="http://schemas.microsoft.com/office/powerpoint/2010/main" val="9110399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graph of dots with numbers&#10;&#10;AI-generated content may be incorrect.">
            <a:extLst>
              <a:ext uri="{FF2B5EF4-FFF2-40B4-BE49-F238E27FC236}">
                <a16:creationId xmlns:a16="http://schemas.microsoft.com/office/drawing/2014/main" id="{B9C32B29-7B01-257F-B321-7465D9B5210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52601"/>
            <a:ext cx="6533894" cy="4122513"/>
          </a:xfrm>
          <a:prstGeom prst="rect">
            <a:avLst/>
          </a:prstGeom>
        </p:spPr>
      </p:pic>
      <p:pic>
        <p:nvPicPr>
          <p:cNvPr id="4" name="Picture 3" descr="A chart with many colored dots&#10;&#10;AI-generated content may be incorrect.">
            <a:extLst>
              <a:ext uri="{FF2B5EF4-FFF2-40B4-BE49-F238E27FC236}">
                <a16:creationId xmlns:a16="http://schemas.microsoft.com/office/drawing/2014/main" id="{B43F13F0-8215-E032-C476-7ADCE64D53D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6357" y="650944"/>
            <a:ext cx="5875643" cy="588367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58763A0-1CBA-7553-C4B3-5A139E7D8B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3526" y="1216668"/>
            <a:ext cx="410690" cy="4669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Box 1">
            <a:extLst>
              <a:ext uri="{FF2B5EF4-FFF2-40B4-BE49-F238E27FC236}">
                <a16:creationId xmlns:a16="http://schemas.microsoft.com/office/drawing/2014/main" id="{98584F85-AE40-AB4D-3E3B-9102FB9875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5903" y="1134442"/>
            <a:ext cx="330097" cy="4669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6446379-F24A-A44B-5BFD-465B7A67FE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384" y="55272"/>
            <a:ext cx="17443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7</a:t>
            </a:r>
          </a:p>
        </p:txBody>
      </p:sp>
    </p:spTree>
    <p:extLst>
      <p:ext uri="{BB962C8B-B14F-4D97-AF65-F5344CB8AC3E}">
        <p14:creationId xmlns:p14="http://schemas.microsoft.com/office/powerpoint/2010/main" val="322548773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00820544-3B4F-22E0-D059-14D0995CFFB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7281" y="1822601"/>
          <a:ext cx="11944719" cy="35134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10059311" imgH="2959386" progId="Prism10.Document">
                  <p:embed/>
                </p:oleObj>
              </mc:Choice>
              <mc:Fallback>
                <p:oleObj name="Prism 10" r:id="rId2" imgW="10059311" imgH="2959386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00820544-3B4F-22E0-D059-14D0995CFFB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47281" y="1822601"/>
                        <a:ext cx="11944719" cy="35134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1C856828-4B66-6828-3806-4DC88C1E51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384" y="55272"/>
            <a:ext cx="17443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S8</a:t>
            </a:r>
          </a:p>
        </p:txBody>
      </p:sp>
    </p:spTree>
    <p:extLst>
      <p:ext uri="{BB962C8B-B14F-4D97-AF65-F5344CB8AC3E}">
        <p14:creationId xmlns:p14="http://schemas.microsoft.com/office/powerpoint/2010/main" val="24229491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13</TotalTime>
  <Words>816</Words>
  <Application>Microsoft Office PowerPoint</Application>
  <PresentationFormat>Widescreen</PresentationFormat>
  <Paragraphs>104</Paragraphs>
  <Slides>12</Slides>
  <Notes>1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ptos</vt:lpstr>
      <vt:lpstr>Aptos Display</vt:lpstr>
      <vt:lpstr>Arial</vt:lpstr>
      <vt:lpstr>Slack-Lato</vt:lpstr>
      <vt:lpstr>Office Theme</vt:lpstr>
      <vt:lpstr>Acrobat Document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d1                      d3                      d7</vt:lpstr>
      <vt:lpstr>PowerPoint Presentation</vt:lpstr>
      <vt:lpstr>PowerPoint Presentation</vt:lpstr>
    </vt:vector>
  </TitlesOfParts>
  <Company>CVMB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osenberg,Corey</dc:creator>
  <cp:lastModifiedBy>Rosenberg,Corey</cp:lastModifiedBy>
  <cp:revision>160</cp:revision>
  <dcterms:created xsi:type="dcterms:W3CDTF">2025-01-30T17:57:20Z</dcterms:created>
  <dcterms:modified xsi:type="dcterms:W3CDTF">2026-01-15T17:58:50Z</dcterms:modified>
</cp:coreProperties>
</file>